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D77FF-483D-446E-93B5-3F45799793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0903C3-6AEB-4EA7-87CF-F556197265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AF57B2-6206-466A-9D7E-44246C487F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00DF04-9B38-4AEB-8570-D42598A8DF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DC640-5890-4D5C-94AA-4635C486B7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83FFE-C57F-4C30-94D3-67EA5D5980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7DDC44-1D7F-4493-9D79-72D6E042EB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AA484D-79B1-4DAA-9FE0-4BF8BAF1C1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8ACEDF-A203-40B6-8D0A-FCC863119E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1CC156-409E-41AB-B913-CB7452F136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181FC7-E00F-4D33-B291-681DA02266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1A369-68E3-4FD6-B7B9-3A03DE679F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9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7DDAA7-2C00-45E1-A1D1-4B81040F4D7C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0"/>
          <p:cNvSpPr/>
          <p:nvPr/>
        </p:nvSpPr>
        <p:spPr>
          <a:xfrm>
            <a:off x="1955880" y="1643040"/>
            <a:ext cx="1422360" cy="135000"/>
          </a:xfrm>
          <a:prstGeom prst="rect">
            <a:avLst/>
          </a:prstGeom>
          <a:solidFill>
            <a:srgbClr val="96e948"/>
          </a:solidFill>
          <a:ln w="6480">
            <a:solidFill>
              <a:srgbClr val="404040"/>
            </a:solidFill>
            <a:round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4"/>
          <p:cNvSpPr/>
          <p:nvPr/>
        </p:nvSpPr>
        <p:spPr>
          <a:xfrm>
            <a:off x="1087560" y="8539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5"/>
          <p:cNvSpPr/>
          <p:nvPr/>
        </p:nvSpPr>
        <p:spPr>
          <a:xfrm>
            <a:off x="1043280" y="21225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6"/>
          <p:cNvGrpSpPr/>
          <p:nvPr/>
        </p:nvGrpSpPr>
        <p:grpSpPr>
          <a:xfrm>
            <a:off x="1033560" y="2733840"/>
            <a:ext cx="1748880" cy="1745640"/>
            <a:chOff x="1033560" y="2733840"/>
            <a:chExt cx="1748880" cy="1745640"/>
          </a:xfrm>
        </p:grpSpPr>
        <p:pic>
          <p:nvPicPr>
            <p:cNvPr id="45" name="Picture 7" descr="11cal35X+S52R_Image003_ch00"/>
            <p:cNvPicPr/>
            <p:nvPr/>
          </p:nvPicPr>
          <p:blipFill>
            <a:blip r:embed="rId1"/>
            <a:stretch/>
          </p:blipFill>
          <p:spPr>
            <a:xfrm>
              <a:off x="1033560" y="2733840"/>
              <a:ext cx="1748880" cy="174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Line 8"/>
            <p:cNvSpPr/>
            <p:nvPr/>
          </p:nvSpPr>
          <p:spPr>
            <a:xfrm>
              <a:off x="2365920" y="4396680"/>
              <a:ext cx="33192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Group 9"/>
          <p:cNvGrpSpPr/>
          <p:nvPr/>
        </p:nvGrpSpPr>
        <p:grpSpPr>
          <a:xfrm>
            <a:off x="4677840" y="2733840"/>
            <a:ext cx="1750680" cy="1737720"/>
            <a:chOff x="4677840" y="2733840"/>
            <a:chExt cx="1750680" cy="1737720"/>
          </a:xfrm>
        </p:grpSpPr>
        <p:pic>
          <p:nvPicPr>
            <p:cNvPr id="48" name="Picture 10" descr="11cal35X+S52R_Snapshot_00"/>
            <p:cNvPicPr/>
            <p:nvPr/>
          </p:nvPicPr>
          <p:blipFill>
            <a:blip r:embed="rId2"/>
            <a:stretch/>
          </p:blipFill>
          <p:spPr>
            <a:xfrm rot="5400000">
              <a:off x="4684320" y="2727360"/>
              <a:ext cx="1737720" cy="1750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Line 11"/>
            <p:cNvSpPr/>
            <p:nvPr/>
          </p:nvSpPr>
          <p:spPr>
            <a:xfrm>
              <a:off x="5941800" y="4413960"/>
              <a:ext cx="42012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Group 12"/>
          <p:cNvGrpSpPr/>
          <p:nvPr/>
        </p:nvGrpSpPr>
        <p:grpSpPr>
          <a:xfrm>
            <a:off x="2860560" y="2733840"/>
            <a:ext cx="1749600" cy="1746000"/>
            <a:chOff x="2860560" y="2733840"/>
            <a:chExt cx="1749600" cy="1746000"/>
          </a:xfrm>
        </p:grpSpPr>
        <p:pic>
          <p:nvPicPr>
            <p:cNvPr id="51" name="Picture 13" descr="11cal35X+RFP-HDEL_Snapshot_00"/>
            <p:cNvPicPr/>
            <p:nvPr/>
          </p:nvPicPr>
          <p:blipFill>
            <a:blip r:embed="rId3"/>
            <a:stretch/>
          </p:blipFill>
          <p:spPr>
            <a:xfrm>
              <a:off x="2860560" y="2733840"/>
              <a:ext cx="1749600" cy="174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Line 14"/>
            <p:cNvSpPr/>
            <p:nvPr/>
          </p:nvSpPr>
          <p:spPr>
            <a:xfrm>
              <a:off x="4120920" y="4408920"/>
              <a:ext cx="41976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Rectangle 15"/>
          <p:cNvSpPr/>
          <p:nvPr/>
        </p:nvSpPr>
        <p:spPr>
          <a:xfrm>
            <a:off x="3327480" y="2422440"/>
            <a:ext cx="81576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Arial Narrow"/>
              </a:rPr>
              <a:t>CNX11-XYLT3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 Narrow"/>
              </a:rPr>
              <a:t>+ mRFP-HDE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6"/>
          <p:cNvSpPr/>
          <p:nvPr/>
        </p:nvSpPr>
        <p:spPr>
          <a:xfrm>
            <a:off x="1449360" y="2398680"/>
            <a:ext cx="917640" cy="36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Arial Narrow"/>
              </a:rPr>
              <a:t>CNX11-XYLT3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8"/>
          <p:cNvSpPr/>
          <p:nvPr/>
        </p:nvSpPr>
        <p:spPr>
          <a:xfrm>
            <a:off x="5029200" y="2397240"/>
            <a:ext cx="1050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Arial Narrow"/>
              </a:rPr>
              <a:t>CNX11-XYLT3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 Narrow"/>
              </a:rPr>
              <a:t>+ ST-mRF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ZoneTexte 18"/>
          <p:cNvSpPr/>
          <p:nvPr/>
        </p:nvSpPr>
        <p:spPr>
          <a:xfrm>
            <a:off x="998640" y="1612800"/>
            <a:ext cx="563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- - - TELIE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EQQPNLTIG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V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V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I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VVVFF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SL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LI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GG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KK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AAPVE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KKK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PEVAESS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SGDEAE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KK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EETAA</a:t>
            </a:r>
            <a:r>
              <a:rPr b="0" lang="en-GB" sz="800" spc="-1" strike="noStrike" u="sng">
                <a:solidFill>
                  <a:srgbClr val="000000"/>
                </a:solidFill>
                <a:uFillTx/>
                <a:latin typeface="Arial"/>
              </a:rPr>
              <a:t>P</a:t>
            </a:r>
            <a:r>
              <a:rPr b="1" lang="en-GB" sz="800" spc="-1" strike="noStrike" u="sng">
                <a:solidFill>
                  <a:srgbClr val="000000"/>
                </a:solidFill>
                <a:uFillTx/>
                <a:latin typeface="Arial"/>
              </a:rPr>
              <a:t>RKR</a:t>
            </a:r>
            <a:r>
              <a:rPr b="0" lang="en-GB" sz="800" spc="-1" strike="noStrike" u="sng">
                <a:solidFill>
                  <a:srgbClr val="000000"/>
                </a:solidFill>
                <a:uFillTx/>
                <a:latin typeface="Arial"/>
              </a:rPr>
              <a:t>QP</a:t>
            </a:r>
            <a:r>
              <a:rPr b="1" lang="en-GB" sz="800" spc="-1" strike="noStrike" u="sng">
                <a:solidFill>
                  <a:srgbClr val="000000"/>
                </a:solidFill>
                <a:uFillTx/>
                <a:latin typeface="Arial"/>
              </a:rPr>
              <a:t>RR</a:t>
            </a:r>
            <a:r>
              <a:rPr b="0" lang="en-GB" sz="800" spc="-1" strike="noStrike" u="sng">
                <a:solidFill>
                  <a:srgbClr val="000000"/>
                </a:solidFill>
                <a:uFillTx/>
                <a:latin typeface="Arial"/>
              </a:rPr>
              <a:t>DN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ZoneTexte 19"/>
          <p:cNvSpPr/>
          <p:nvPr/>
        </p:nvSpPr>
        <p:spPr>
          <a:xfrm>
            <a:off x="1039680" y="1231920"/>
            <a:ext cx="3530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Transmembrane domain and C-terminal end of calnex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ZoneTexte 21"/>
          <p:cNvSpPr/>
          <p:nvPr/>
        </p:nvSpPr>
        <p:spPr>
          <a:xfrm>
            <a:off x="2424960" y="1447920"/>
            <a:ext cx="45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7f7f7f"/>
                </a:solidFill>
                <a:latin typeface="Arial"/>
              </a:rPr>
              <a:t>TM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28T13:37:03Z</dcterms:created>
  <dc:creator>GOMORD</dc:creator>
  <dc:description/>
  <dc:language>en-US</dc:language>
  <cp:lastModifiedBy>Veronique GOMORD</cp:lastModifiedBy>
  <dcterms:modified xsi:type="dcterms:W3CDTF">2009-11-18T13:34:40Z</dcterms:modified>
  <cp:revision>37</cp:revision>
  <dc:subject/>
  <dc:title>Diapositive 1</dc:title>
</cp:coreProperties>
</file>